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8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9B3953-635E-A5B9-BA0A-1239E83A51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42F9AE5-A4CD-69F2-0054-BAAA4A3DD0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77DA6C-26DA-5EC1-D686-174A54FD59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65EDF88-5781-C017-CC0A-9AEE8E9CF7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791719-F586-B73B-4911-B41D97FCE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4480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F22EB4-16A4-AA79-0D90-A37EA28F6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F34E946-2DD6-5433-66B1-9B70D33563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9558DD-B138-9589-CB74-2F6FE3F77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86EA81-219C-D085-508B-0A9FEAFE1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B03C3A-95EA-11DE-2571-469BE5225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83262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A73F5BE-051E-BF08-C09B-77652342C2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86E2210-2D80-4D7A-67E6-342BE8CA45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F464B3-4293-89BB-83D6-8CEF7C877F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744C95-ABEF-483B-873F-73C77A6DF2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EC6456-D198-219A-5554-EBF025C99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1413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EBDFA25-A1E9-A602-C173-6CC406B307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B66C248-DCC9-1FD5-8815-BE6EA7C9B5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BF58E4-6815-AD05-EB40-709BAB771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72564C3-FD2C-4753-28FC-4BF9982E8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DF6640-491F-229C-7263-69C79CBEA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214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8132D3-8579-39DC-4964-C8CBDCB8F6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6A55A84-A486-723C-D466-88F3DFA223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B26F2C-66AE-94E0-D0A5-BCA7491B16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A5E6B7-E5E0-4610-92DE-EBAE1948E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022E08-01CF-7774-28C6-BE82739E19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802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1F70C9-9B49-62BF-62A8-4FF0DF5DAD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DD3AF90-BD17-FFD6-42C9-2EBE03A492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25264F5-5E3C-6635-F896-80D4111D5C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3C192C3-F769-2D61-0595-E0D15C862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64115F4-7D98-11B8-1D17-BBBA0A24C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2A8410D-DBC3-B548-8FBD-A0832CD0F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437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4B30E9-4A9A-F8DC-27BB-5C0C52AA47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A033A8D-466E-5E1C-D0CB-528B1032E8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6D4FDB0-4EF1-5A99-85D0-CDAB2A18F9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9538AF2-FE02-9095-03A6-88B52C9528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5453132-9840-F1AB-3AAA-FAF1679ABA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3C17786-68E9-0A44-D52C-85EA5AB53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B6E2851-8B97-B810-02C0-91D9D0360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ADE02EC-81AB-3355-0FB6-175912E82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1061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0AE4EC-A66E-F670-6EC2-AEA8EA635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5B1B0C3-0746-B26C-20CC-C35D6E304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FE7D29D-8EE6-A101-5432-A310C5A5C2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E724828-5F66-AF89-A9CB-26F037B974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5139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7CA885C-1223-4561-AC46-A10D81482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616671C-CBD6-179C-4AF0-C5D828C917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8BAB3E1-F477-D97E-4C62-27FB17F4C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7510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4D1D32-0069-60F9-DD87-7FFD672A7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7DE9D56-6BA1-1479-223A-1A09524866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F5862E-9092-6463-494F-5FBB893074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2707F28-6541-1F80-6455-447268561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39C6D7C-3D0F-FDD3-DA17-E3E7CED0C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3DD2701-FA7E-FA54-4C88-8199A6DE3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05984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69A876-4F83-4A44-FDAB-DEB295C12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9A71792-B25E-5349-6AD5-81E5E72EC7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EAC490B-9A06-3F5D-1400-CC3F2CF94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35C49EC-CEB3-0A56-AB7E-4EE512DF30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C199B2B-F0CE-9651-E0EE-34DD305B1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26E16B-AC5E-78CD-ABFC-A75FAB21CD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437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C856F75-086E-EA63-19E9-2B48D76146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8A85348-5307-B637-19B8-F3C4E25FB8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6E689A-952C-A8F0-8151-5668EA466A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6F78B8-955A-4437-A38A-CFE5B47C03CB}" type="datetimeFigureOut">
              <a:rPr lang="zh-CN" altLang="en-US" smtClean="0"/>
              <a:t>2023/5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8B7ECA-1342-CD63-EF91-5352844B6D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D33164-FCC8-0CE5-E190-6C127485E5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B5ACA-61E7-4AF7-9479-C5E414D7EB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5779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099CE8F-4A2B-31B9-4EE7-261C54E6E4F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066" t="39362" r="30657" b="15917"/>
          <a:stretch/>
        </p:blipFill>
        <p:spPr>
          <a:xfrm>
            <a:off x="3378155" y="1132669"/>
            <a:ext cx="4233344" cy="4310968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BE03460A-A8E0-0F16-8A49-C6CB09DE7BF0}"/>
              </a:ext>
            </a:extLst>
          </p:cNvPr>
          <p:cNvSpPr/>
          <p:nvPr/>
        </p:nvSpPr>
        <p:spPr>
          <a:xfrm>
            <a:off x="4291014" y="1862139"/>
            <a:ext cx="2528420" cy="1596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1C23820-D6DA-767E-02F4-61918AC49C34}"/>
              </a:ext>
            </a:extLst>
          </p:cNvPr>
          <p:cNvSpPr txBox="1"/>
          <p:nvPr/>
        </p:nvSpPr>
        <p:spPr>
          <a:xfrm>
            <a:off x="7611499" y="1757298"/>
            <a:ext cx="11994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6 k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A7ABDD8-2A42-9259-499A-D48139329F09}"/>
              </a:ext>
            </a:extLst>
          </p:cNvPr>
          <p:cNvSpPr txBox="1"/>
          <p:nvPr/>
        </p:nvSpPr>
        <p:spPr>
          <a:xfrm>
            <a:off x="2306973" y="1799026"/>
            <a:ext cx="968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/>
              <a:t>CARM1</a:t>
            </a:r>
            <a:endParaRPr lang="zh-CN" altLang="en-US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002341F0-43D8-4032-DAD9-83B3AD8382DE}"/>
              </a:ext>
            </a:extLst>
          </p:cNvPr>
          <p:cNvSpPr txBox="1"/>
          <p:nvPr/>
        </p:nvSpPr>
        <p:spPr>
          <a:xfrm>
            <a:off x="4102217" y="763337"/>
            <a:ext cx="1524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/>
              <a:t>sh</a:t>
            </a:r>
            <a:r>
              <a:rPr lang="en-US" altLang="zh-CN" sz="1600" b="1" dirty="0"/>
              <a:t>-NC shRNA</a:t>
            </a:r>
            <a:endParaRPr lang="zh-CN" altLang="en-US" sz="1600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7AEE92D-25A6-F94E-815F-8749A796FB45}"/>
              </a:ext>
            </a:extLst>
          </p:cNvPr>
          <p:cNvSpPr txBox="1"/>
          <p:nvPr/>
        </p:nvSpPr>
        <p:spPr>
          <a:xfrm>
            <a:off x="5494827" y="769883"/>
            <a:ext cx="1524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/>
              <a:t>sh</a:t>
            </a:r>
            <a:r>
              <a:rPr lang="en-US" altLang="zh-CN" sz="1600" b="1" dirty="0"/>
              <a:t>-NC shRNA</a:t>
            </a:r>
            <a:endParaRPr lang="zh-CN" altLang="en-US" sz="1600" b="1" dirty="0"/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87AF3503-2BF9-7192-3BC5-9F62721E3AAB}"/>
              </a:ext>
            </a:extLst>
          </p:cNvPr>
          <p:cNvCxnSpPr>
            <a:cxnSpLocks/>
          </p:cNvCxnSpPr>
          <p:nvPr/>
        </p:nvCxnSpPr>
        <p:spPr>
          <a:xfrm>
            <a:off x="4230877" y="732559"/>
            <a:ext cx="118087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99DA1CD2-2B95-6204-527E-407250B0CEEB}"/>
              </a:ext>
            </a:extLst>
          </p:cNvPr>
          <p:cNvCxnSpPr>
            <a:cxnSpLocks/>
          </p:cNvCxnSpPr>
          <p:nvPr/>
        </p:nvCxnSpPr>
        <p:spPr>
          <a:xfrm>
            <a:off x="5626993" y="731110"/>
            <a:ext cx="119244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8D09FC18-B8BA-2921-0617-19F4CC679083}"/>
              </a:ext>
            </a:extLst>
          </p:cNvPr>
          <p:cNvSpPr txBox="1"/>
          <p:nvPr/>
        </p:nvSpPr>
        <p:spPr>
          <a:xfrm>
            <a:off x="4487780" y="377892"/>
            <a:ext cx="6896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/>
              <a:t>CNE2</a:t>
            </a:r>
            <a:endParaRPr lang="zh-CN" altLang="en-US" sz="160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5A0F3BB-C700-417E-2436-CB3FEC54C9C2}"/>
              </a:ext>
            </a:extLst>
          </p:cNvPr>
          <p:cNvSpPr txBox="1"/>
          <p:nvPr/>
        </p:nvSpPr>
        <p:spPr>
          <a:xfrm>
            <a:off x="5878407" y="373170"/>
            <a:ext cx="8707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/>
              <a:t>C666</a:t>
            </a:r>
            <a:r>
              <a:rPr lang="en-US" altLang="zh-CN" sz="1600" b="1" dirty="0"/>
              <a:t>-1</a:t>
            </a:r>
            <a:endParaRPr lang="zh-CN" altLang="en-US" sz="16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5969A57-9D17-5316-9010-CE7385242CD6}"/>
              </a:ext>
            </a:extLst>
          </p:cNvPr>
          <p:cNvSpPr txBox="1"/>
          <p:nvPr/>
        </p:nvSpPr>
        <p:spPr>
          <a:xfrm>
            <a:off x="3392591" y="763337"/>
            <a:ext cx="8483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Marker</a:t>
            </a:r>
            <a:endParaRPr lang="zh-CN" altLang="en-US" sz="16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17307F8-3B1E-A515-76F6-A92C35418480}"/>
              </a:ext>
            </a:extLst>
          </p:cNvPr>
          <p:cNvSpPr txBox="1"/>
          <p:nvPr/>
        </p:nvSpPr>
        <p:spPr>
          <a:xfrm>
            <a:off x="6835139" y="745651"/>
            <a:ext cx="8483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Marker</a:t>
            </a:r>
            <a:endParaRPr lang="zh-CN" alt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310456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EA53B6E1-5212-4BDC-098F-2F6241BA0B7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559" t="28646" r="28436" b="21915"/>
          <a:stretch/>
        </p:blipFill>
        <p:spPr>
          <a:xfrm>
            <a:off x="3558449" y="985013"/>
            <a:ext cx="4746525" cy="4887973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29F19ED1-08E0-7841-0F44-DCBAD015E91D}"/>
              </a:ext>
            </a:extLst>
          </p:cNvPr>
          <p:cNvSpPr/>
          <p:nvPr/>
        </p:nvSpPr>
        <p:spPr>
          <a:xfrm>
            <a:off x="4544008" y="3032449"/>
            <a:ext cx="2519265" cy="1399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5054B2CC-10A6-D939-676E-E1A94CF705CA}"/>
              </a:ext>
            </a:extLst>
          </p:cNvPr>
          <p:cNvSpPr txBox="1"/>
          <p:nvPr/>
        </p:nvSpPr>
        <p:spPr>
          <a:xfrm>
            <a:off x="8416842" y="2917762"/>
            <a:ext cx="11994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3 k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FEABC54-E5D3-7BA2-0416-BA88BE0C2030}"/>
              </a:ext>
            </a:extLst>
          </p:cNvPr>
          <p:cNvSpPr txBox="1"/>
          <p:nvPr/>
        </p:nvSpPr>
        <p:spPr>
          <a:xfrm>
            <a:off x="4326157" y="651365"/>
            <a:ext cx="1524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/>
              <a:t>sh</a:t>
            </a:r>
            <a:r>
              <a:rPr lang="en-US" altLang="zh-CN" sz="1600" b="1" dirty="0"/>
              <a:t>-NC shRNA</a:t>
            </a:r>
            <a:endParaRPr lang="zh-CN" altLang="en-US" sz="1600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B496105-844B-80B4-76A9-D8BAAEE602F0}"/>
              </a:ext>
            </a:extLst>
          </p:cNvPr>
          <p:cNvSpPr txBox="1"/>
          <p:nvPr/>
        </p:nvSpPr>
        <p:spPr>
          <a:xfrm>
            <a:off x="5718767" y="657911"/>
            <a:ext cx="1524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/>
              <a:t>sh</a:t>
            </a:r>
            <a:r>
              <a:rPr lang="en-US" altLang="zh-CN" sz="1600" b="1" dirty="0"/>
              <a:t>-NC shRNA</a:t>
            </a:r>
            <a:endParaRPr lang="zh-CN" altLang="en-US" sz="1600" b="1" dirty="0"/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3BD97C4B-375E-6BC1-7125-C8B8D0C14A3E}"/>
              </a:ext>
            </a:extLst>
          </p:cNvPr>
          <p:cNvCxnSpPr>
            <a:cxnSpLocks/>
          </p:cNvCxnSpPr>
          <p:nvPr/>
        </p:nvCxnSpPr>
        <p:spPr>
          <a:xfrm>
            <a:off x="4454817" y="620587"/>
            <a:ext cx="118087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960BE2DD-472A-0120-47ED-BABF7B524E2D}"/>
              </a:ext>
            </a:extLst>
          </p:cNvPr>
          <p:cNvCxnSpPr>
            <a:cxnSpLocks/>
          </p:cNvCxnSpPr>
          <p:nvPr/>
        </p:nvCxnSpPr>
        <p:spPr>
          <a:xfrm>
            <a:off x="5850933" y="619138"/>
            <a:ext cx="119244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7695ABA3-F966-CF8A-2A7E-F752A8200BD1}"/>
              </a:ext>
            </a:extLst>
          </p:cNvPr>
          <p:cNvSpPr txBox="1"/>
          <p:nvPr/>
        </p:nvSpPr>
        <p:spPr>
          <a:xfrm>
            <a:off x="4711720" y="265920"/>
            <a:ext cx="6896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/>
              <a:t>CNE2</a:t>
            </a:r>
            <a:endParaRPr lang="zh-CN" altLang="en-US" sz="16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6BC1061-E434-1EF0-3A91-07A4494BA7DA}"/>
              </a:ext>
            </a:extLst>
          </p:cNvPr>
          <p:cNvSpPr txBox="1"/>
          <p:nvPr/>
        </p:nvSpPr>
        <p:spPr>
          <a:xfrm>
            <a:off x="6102347" y="261198"/>
            <a:ext cx="8707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/>
              <a:t>C666</a:t>
            </a:r>
            <a:r>
              <a:rPr lang="en-US" altLang="zh-CN" sz="1600" b="1" dirty="0"/>
              <a:t>-1</a:t>
            </a:r>
            <a:endParaRPr lang="zh-CN" altLang="en-US" sz="1600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3622340-13F2-C3C4-081A-24081C7D9BC5}"/>
              </a:ext>
            </a:extLst>
          </p:cNvPr>
          <p:cNvSpPr txBox="1"/>
          <p:nvPr/>
        </p:nvSpPr>
        <p:spPr>
          <a:xfrm>
            <a:off x="3616531" y="651365"/>
            <a:ext cx="8483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Marker</a:t>
            </a:r>
            <a:endParaRPr lang="zh-CN" altLang="en-US" sz="16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55AF39E-4DD1-065A-CA81-CDCFBCD8C67C}"/>
              </a:ext>
            </a:extLst>
          </p:cNvPr>
          <p:cNvSpPr txBox="1"/>
          <p:nvPr/>
        </p:nvSpPr>
        <p:spPr>
          <a:xfrm>
            <a:off x="7059079" y="633679"/>
            <a:ext cx="8483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/>
              <a:t>Marker</a:t>
            </a:r>
            <a:endParaRPr lang="zh-CN" altLang="en-US" sz="16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439F15A-A003-27FF-D2AE-14712176DFC1}"/>
              </a:ext>
            </a:extLst>
          </p:cNvPr>
          <p:cNvSpPr txBox="1"/>
          <p:nvPr/>
        </p:nvSpPr>
        <p:spPr>
          <a:xfrm>
            <a:off x="2478046" y="2917762"/>
            <a:ext cx="763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/>
              <a:t>CCD2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0884070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37DDA07-3759-9D89-AEA9-68AA0B2F7B2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"/>
                    </a14:imgEffect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041" t="41333" r="30629" b="11019"/>
          <a:stretch/>
        </p:blipFill>
        <p:spPr>
          <a:xfrm>
            <a:off x="3400845" y="1113665"/>
            <a:ext cx="3803899" cy="4265207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2077354D-2A0E-CCB6-6DDE-FB001310B225}"/>
              </a:ext>
            </a:extLst>
          </p:cNvPr>
          <p:cNvSpPr/>
          <p:nvPr/>
        </p:nvSpPr>
        <p:spPr>
          <a:xfrm>
            <a:off x="4189445" y="3790950"/>
            <a:ext cx="2239347" cy="1465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C43ACB2-D75A-77A6-90AA-CA27243E3616}"/>
              </a:ext>
            </a:extLst>
          </p:cNvPr>
          <p:cNvSpPr txBox="1"/>
          <p:nvPr/>
        </p:nvSpPr>
        <p:spPr>
          <a:xfrm>
            <a:off x="7393634" y="3679568"/>
            <a:ext cx="11994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8 k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0DBDE85F-D315-BEC0-32C2-FF951F4B4D44}"/>
              </a:ext>
            </a:extLst>
          </p:cNvPr>
          <p:cNvSpPr txBox="1"/>
          <p:nvPr/>
        </p:nvSpPr>
        <p:spPr>
          <a:xfrm>
            <a:off x="3990245" y="772668"/>
            <a:ext cx="1306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/>
              <a:t>sh</a:t>
            </a:r>
            <a:r>
              <a:rPr lang="en-US" altLang="zh-CN" sz="1400" b="1" dirty="0"/>
              <a:t>-NC shRNA</a:t>
            </a:r>
            <a:endParaRPr lang="zh-CN" altLang="en-US" sz="1400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9CEAB92-8E62-EA6D-6FF6-4099C8340B4D}"/>
              </a:ext>
            </a:extLst>
          </p:cNvPr>
          <p:cNvSpPr txBox="1"/>
          <p:nvPr/>
        </p:nvSpPr>
        <p:spPr>
          <a:xfrm>
            <a:off x="5270883" y="779214"/>
            <a:ext cx="1306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/>
              <a:t>sh</a:t>
            </a:r>
            <a:r>
              <a:rPr lang="en-US" altLang="zh-CN" sz="1400" b="1" dirty="0"/>
              <a:t>-NC shRNA</a:t>
            </a:r>
            <a:endParaRPr lang="zh-CN" altLang="en-US" sz="1400" b="1" dirty="0"/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BECCB119-78F0-535A-8451-FF5210A64FE1}"/>
              </a:ext>
            </a:extLst>
          </p:cNvPr>
          <p:cNvCxnSpPr>
            <a:cxnSpLocks/>
          </p:cNvCxnSpPr>
          <p:nvPr/>
        </p:nvCxnSpPr>
        <p:spPr>
          <a:xfrm>
            <a:off x="4118905" y="741890"/>
            <a:ext cx="99427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4802C00B-087B-E795-8CE3-7084B9C12126}"/>
              </a:ext>
            </a:extLst>
          </p:cNvPr>
          <p:cNvCxnSpPr>
            <a:cxnSpLocks/>
          </p:cNvCxnSpPr>
          <p:nvPr/>
        </p:nvCxnSpPr>
        <p:spPr>
          <a:xfrm>
            <a:off x="5403049" y="740441"/>
            <a:ext cx="108684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7F6FC13B-D181-9C8D-5D5E-8B929BA99B34}"/>
              </a:ext>
            </a:extLst>
          </p:cNvPr>
          <p:cNvSpPr txBox="1"/>
          <p:nvPr/>
        </p:nvSpPr>
        <p:spPr>
          <a:xfrm>
            <a:off x="4375808" y="387223"/>
            <a:ext cx="6270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/>
              <a:t>CNE2</a:t>
            </a:r>
            <a:endParaRPr lang="zh-CN" altLang="en-US" sz="14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5386CE4-D52F-8FF3-AE91-9BAA735E3FA0}"/>
              </a:ext>
            </a:extLst>
          </p:cNvPr>
          <p:cNvSpPr txBox="1"/>
          <p:nvPr/>
        </p:nvSpPr>
        <p:spPr>
          <a:xfrm>
            <a:off x="5654463" y="382501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/>
              <a:t>C666</a:t>
            </a:r>
            <a:r>
              <a:rPr lang="en-US" altLang="zh-CN" sz="1400" b="1" dirty="0"/>
              <a:t>-1</a:t>
            </a:r>
            <a:endParaRPr lang="zh-CN" altLang="en-US" sz="1400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6A25830-D8B5-FCF2-F1AC-BA90CC964747}"/>
              </a:ext>
            </a:extLst>
          </p:cNvPr>
          <p:cNvSpPr txBox="1"/>
          <p:nvPr/>
        </p:nvSpPr>
        <p:spPr>
          <a:xfrm>
            <a:off x="3327274" y="772668"/>
            <a:ext cx="7665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Marker</a:t>
            </a:r>
            <a:endParaRPr lang="zh-CN" altLang="en-US" sz="14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4FC3DBA-9907-F9E4-FD4A-70323BA8C95B}"/>
              </a:ext>
            </a:extLst>
          </p:cNvPr>
          <p:cNvSpPr txBox="1"/>
          <p:nvPr/>
        </p:nvSpPr>
        <p:spPr>
          <a:xfrm>
            <a:off x="6489892" y="754982"/>
            <a:ext cx="7665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Marker</a:t>
            </a:r>
            <a:endParaRPr lang="zh-CN" altLang="en-US" sz="14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0256636-5F64-008F-C44A-9A6FBFD5221A}"/>
              </a:ext>
            </a:extLst>
          </p:cNvPr>
          <p:cNvSpPr txBox="1"/>
          <p:nvPr/>
        </p:nvSpPr>
        <p:spPr>
          <a:xfrm>
            <a:off x="2636156" y="3679568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err="1"/>
              <a:t>P21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9788725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C3B3DDB1-9681-2F71-E2A8-785C1BAFB0B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040" t="39309" r="33520" b="16100"/>
          <a:stretch/>
        </p:blipFill>
        <p:spPr>
          <a:xfrm>
            <a:off x="3368584" y="1123073"/>
            <a:ext cx="4179705" cy="4220440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C08337E4-2DF2-BA1D-3439-3247949418A0}"/>
              </a:ext>
            </a:extLst>
          </p:cNvPr>
          <p:cNvSpPr/>
          <p:nvPr/>
        </p:nvSpPr>
        <p:spPr>
          <a:xfrm>
            <a:off x="4198803" y="2467241"/>
            <a:ext cx="2519265" cy="1399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B352743-5278-C871-4573-81FC8AC340B6}"/>
              </a:ext>
            </a:extLst>
          </p:cNvPr>
          <p:cNvSpPr txBox="1"/>
          <p:nvPr/>
        </p:nvSpPr>
        <p:spPr>
          <a:xfrm>
            <a:off x="7628526" y="2352554"/>
            <a:ext cx="11994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2 k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4041CD9-459E-5524-7E91-06CA92EAF1A6}"/>
              </a:ext>
            </a:extLst>
          </p:cNvPr>
          <p:cNvSpPr txBox="1"/>
          <p:nvPr/>
        </p:nvSpPr>
        <p:spPr>
          <a:xfrm>
            <a:off x="4102217" y="763337"/>
            <a:ext cx="1306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/>
              <a:t>sh</a:t>
            </a:r>
            <a:r>
              <a:rPr lang="en-US" altLang="zh-CN" sz="1400" b="1" dirty="0"/>
              <a:t>-NC shRNA</a:t>
            </a:r>
            <a:endParaRPr lang="zh-CN" altLang="en-US" sz="1400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9A5E220-7CA2-E866-F997-D213E8140AFD}"/>
              </a:ext>
            </a:extLst>
          </p:cNvPr>
          <p:cNvSpPr txBox="1"/>
          <p:nvPr/>
        </p:nvSpPr>
        <p:spPr>
          <a:xfrm>
            <a:off x="5494827" y="769883"/>
            <a:ext cx="1306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/>
              <a:t>sh</a:t>
            </a:r>
            <a:r>
              <a:rPr lang="en-US" altLang="zh-CN" sz="1400" b="1" dirty="0"/>
              <a:t>-NC shRNA</a:t>
            </a:r>
            <a:endParaRPr lang="zh-CN" altLang="en-US" sz="1400" b="1" dirty="0"/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DCD3E7A9-D1ED-99DD-F0B9-84DA6DD944AB}"/>
              </a:ext>
            </a:extLst>
          </p:cNvPr>
          <p:cNvCxnSpPr>
            <a:cxnSpLocks/>
          </p:cNvCxnSpPr>
          <p:nvPr/>
        </p:nvCxnSpPr>
        <p:spPr>
          <a:xfrm flipV="1">
            <a:off x="4230877" y="731110"/>
            <a:ext cx="994266" cy="144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D43FD892-D140-1AE8-F0FE-2AE5E6E1D0E1}"/>
              </a:ext>
            </a:extLst>
          </p:cNvPr>
          <p:cNvCxnSpPr>
            <a:cxnSpLocks/>
          </p:cNvCxnSpPr>
          <p:nvPr/>
        </p:nvCxnSpPr>
        <p:spPr>
          <a:xfrm>
            <a:off x="5626993" y="731110"/>
            <a:ext cx="109107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AC566850-522D-F3E2-0B12-1B5B1E451A02}"/>
              </a:ext>
            </a:extLst>
          </p:cNvPr>
          <p:cNvSpPr txBox="1"/>
          <p:nvPr/>
        </p:nvSpPr>
        <p:spPr>
          <a:xfrm>
            <a:off x="4487780" y="377892"/>
            <a:ext cx="6270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/>
              <a:t>CNE2</a:t>
            </a:r>
            <a:endParaRPr lang="zh-CN" altLang="en-US" sz="14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09AF02B-8CB5-EBD9-5013-7811153108E4}"/>
              </a:ext>
            </a:extLst>
          </p:cNvPr>
          <p:cNvSpPr txBox="1"/>
          <p:nvPr/>
        </p:nvSpPr>
        <p:spPr>
          <a:xfrm>
            <a:off x="5766435" y="373170"/>
            <a:ext cx="7841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/>
              <a:t>C666</a:t>
            </a:r>
            <a:r>
              <a:rPr lang="en-US" altLang="zh-CN" sz="1400" b="1" dirty="0"/>
              <a:t>-1</a:t>
            </a:r>
            <a:endParaRPr lang="zh-CN" altLang="en-US" sz="1400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944B612-D60A-8DE5-246F-56B89F730E2F}"/>
              </a:ext>
            </a:extLst>
          </p:cNvPr>
          <p:cNvSpPr txBox="1"/>
          <p:nvPr/>
        </p:nvSpPr>
        <p:spPr>
          <a:xfrm>
            <a:off x="3392591" y="763337"/>
            <a:ext cx="7665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Marker</a:t>
            </a:r>
            <a:endParaRPr lang="zh-CN" altLang="en-US" sz="14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CA796A4-8770-5609-A287-A976DBFF665D}"/>
              </a:ext>
            </a:extLst>
          </p:cNvPr>
          <p:cNvSpPr txBox="1"/>
          <p:nvPr/>
        </p:nvSpPr>
        <p:spPr>
          <a:xfrm>
            <a:off x="6723167" y="754982"/>
            <a:ext cx="7665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Marker</a:t>
            </a:r>
            <a:endParaRPr lang="zh-CN" altLang="en-US" sz="14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0FA1621B-B419-40FE-57FD-9239D7A6D92E}"/>
              </a:ext>
            </a:extLst>
          </p:cNvPr>
          <p:cNvSpPr txBox="1"/>
          <p:nvPr/>
        </p:nvSpPr>
        <p:spPr>
          <a:xfrm>
            <a:off x="2326224" y="2352554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Symbol" panose="05050102010706020507" pitchFamily="18" charset="2"/>
              </a:rPr>
              <a:t>b</a:t>
            </a:r>
            <a:r>
              <a:rPr lang="en-US" altLang="zh-CN" b="1" dirty="0"/>
              <a:t>-actin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979304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0</TotalTime>
  <Words>48</Words>
  <Application>Microsoft Office PowerPoint</Application>
  <PresentationFormat>宽屏</PresentationFormat>
  <Paragraphs>32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Symbo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yunbin</dc:creator>
  <cp:lastModifiedBy>28507</cp:lastModifiedBy>
  <cp:revision>7</cp:revision>
  <dcterms:created xsi:type="dcterms:W3CDTF">2023-05-04T08:34:46Z</dcterms:created>
  <dcterms:modified xsi:type="dcterms:W3CDTF">2023-05-05T09:26:57Z</dcterms:modified>
</cp:coreProperties>
</file>